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7E94B0-EC76-4BE7-9EB6-374E93E89D16}" v="4" dt="2020-02-24T07:11:44.2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1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314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 Meyers" userId="470a02ee-1e65-42af-a6dc-85a5b9f23514" providerId="ADAL" clId="{607E94B0-EC76-4BE7-9EB6-374E93E89D16}"/>
    <pc:docChg chg="modSld">
      <pc:chgData name="Ann Meyers" userId="470a02ee-1e65-42af-a6dc-85a5b9f23514" providerId="ADAL" clId="{607E94B0-EC76-4BE7-9EB6-374E93E89D16}" dt="2020-02-24T07:11:49.120" v="21" actId="20577"/>
      <pc:docMkLst>
        <pc:docMk/>
      </pc:docMkLst>
      <pc:sldChg chg="addSp modSp">
        <pc:chgData name="Ann Meyers" userId="470a02ee-1e65-42af-a6dc-85a5b9f23514" providerId="ADAL" clId="{607E94B0-EC76-4BE7-9EB6-374E93E89D16}" dt="2020-02-24T07:11:49.120" v="21" actId="20577"/>
        <pc:sldMkLst>
          <pc:docMk/>
          <pc:sldMk cId="1252442819" sldId="256"/>
        </pc:sldMkLst>
        <pc:spChg chg="add mod">
          <ac:chgData name="Ann Meyers" userId="470a02ee-1e65-42af-a6dc-85a5b9f23514" providerId="ADAL" clId="{607E94B0-EC76-4BE7-9EB6-374E93E89D16}" dt="2020-02-24T07:11:49.120" v="21" actId="20577"/>
          <ac:spMkLst>
            <pc:docMk/>
            <pc:sldMk cId="1252442819" sldId="256"/>
            <ac:spMk id="2" creationId="{AEBA1DF1-6830-4762-ACCF-9239C0A4DFA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7470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53260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02887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0019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74413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81260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39369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32958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1901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726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2565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7983E-79A4-428D-B6B3-010FEA863E4C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D6E7E-0795-4DF1-B2D9-E00AE676C7B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60269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0151409-4AEE-4D78-B886-CA6E2A3781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81" y="817783"/>
            <a:ext cx="6815919" cy="4523624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AEBA1DF1-6830-4762-ACCF-9239C0A4DFA5}"/>
              </a:ext>
            </a:extLst>
          </p:cNvPr>
          <p:cNvSpPr/>
          <p:nvPr/>
        </p:nvSpPr>
        <p:spPr>
          <a:xfrm>
            <a:off x="434898" y="5902001"/>
            <a:ext cx="598820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ting to detect expression of recombinant HIV gp140 following the co-expression of A) huma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) ERp5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qual amounts of crude leaf lysate were resolved by SDS-PAGE and the recombinant HIV glycoprotein was detected with polyclonal goat anti-gp120. (MW = molecular weight marker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only, gp140/CRT = co-expression of gp140 and CRT, gp140/CRT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co-expression of gp140, CRT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p140 = gp140 expression only, gp140/ERp57 = co-expression of gp140 and ERp57, gp140/CRT/ERp57 = co-expression of gp140, CRT and ERp57).</a:t>
            </a:r>
            <a:endParaRPr lang="en-Z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2442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A2F3BAF291F44B9BAC9868B50C80F1" ma:contentTypeVersion="13" ma:contentTypeDescription="Create a new document." ma:contentTypeScope="" ma:versionID="bc4a9a0540e0ef972c7ebd2a0284d042">
  <xsd:schema xmlns:xsd="http://www.w3.org/2001/XMLSchema" xmlns:xs="http://www.w3.org/2001/XMLSchema" xmlns:p="http://schemas.microsoft.com/office/2006/metadata/properties" xmlns:ns3="dcca6e4b-f4d1-4c2f-83f7-8a9b9cca29ae" xmlns:ns4="220f49fd-4060-4647-a9a5-4c9032b44770" targetNamespace="http://schemas.microsoft.com/office/2006/metadata/properties" ma:root="true" ma:fieldsID="875b4c7d21ae34cbc3f1277f276c462c" ns3:_="" ns4:_="">
    <xsd:import namespace="dcca6e4b-f4d1-4c2f-83f7-8a9b9cca29ae"/>
    <xsd:import namespace="220f49fd-4060-4647-a9a5-4c9032b447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ca6e4b-f4d1-4c2f-83f7-8a9b9cca29a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0f49fd-4060-4647-a9a5-4c9032b44770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D63D5B5-9FBB-4CBC-B2B0-3F2F41E8B93A}">
  <ds:schemaRefs>
    <ds:schemaRef ds:uri="http://purl.org/dc/elements/1.1/"/>
    <ds:schemaRef ds:uri="http://schemas.microsoft.com/office/2006/metadata/properties"/>
    <ds:schemaRef ds:uri="220f49fd-4060-4647-a9a5-4c9032b44770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dcca6e4b-f4d1-4c2f-83f7-8a9b9cca29ae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106AE05-2544-4F85-BC89-5188AE9E2EA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075C7CD-BA2F-40AD-A842-CEC1335BC89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cca6e4b-f4d1-4c2f-83f7-8a9b9cca29ae"/>
    <ds:schemaRef ds:uri="220f49fd-4060-4647-a9a5-4c9032b447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1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Meyers</dc:creator>
  <cp:lastModifiedBy>Ann Meyers</cp:lastModifiedBy>
  <cp:revision>1</cp:revision>
  <dcterms:created xsi:type="dcterms:W3CDTF">2020-02-03T10:34:28Z</dcterms:created>
  <dcterms:modified xsi:type="dcterms:W3CDTF">2020-02-24T07:11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A2F3BAF291F44B9BAC9868B50C80F1</vt:lpwstr>
  </property>
</Properties>
</file>